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76" r:id="rId3"/>
    <p:sldId id="300" r:id="rId4"/>
    <p:sldId id="301" r:id="rId5"/>
    <p:sldId id="302" r:id="rId6"/>
    <p:sldId id="280" r:id="rId7"/>
    <p:sldId id="303" r:id="rId8"/>
    <p:sldId id="304" r:id="rId9"/>
    <p:sldId id="305" r:id="rId10"/>
    <p:sldId id="257" r:id="rId11"/>
    <p:sldId id="285" r:id="rId12"/>
    <p:sldId id="261" r:id="rId13"/>
    <p:sldId id="288" r:id="rId14"/>
    <p:sldId id="289" r:id="rId15"/>
    <p:sldId id="292" r:id="rId16"/>
    <p:sldId id="293" r:id="rId17"/>
    <p:sldId id="269" r:id="rId18"/>
    <p:sldId id="295" r:id="rId19"/>
    <p:sldId id="296" r:id="rId20"/>
    <p:sldId id="297" r:id="rId21"/>
    <p:sldId id="273" r:id="rId22"/>
    <p:sldId id="299" r:id="rId2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10823F44-C407-4217-A77D-36EA873C103F}" v="98" dt="2024-05-29T00:42:03.9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34"/>
  </p:normalViewPr>
  <p:slideViewPr>
    <p:cSldViewPr snapToGrid="0">
      <p:cViewPr varScale="1">
        <p:scale>
          <a:sx n="91" d="100"/>
          <a:sy n="91" d="100"/>
        </p:scale>
        <p:origin x="264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microsoft.com/office/2016/11/relationships/changesInfo" Target="changesInfos/changesInfo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a Beaver" clId="Web-{10823F44-C407-4217-A77D-36EA873C103F}"/>
    <pc:docChg chg="modSld">
      <pc:chgData name="Laura Beaver" userId="" providerId="" clId="Web-{10823F44-C407-4217-A77D-36EA873C103F}" dt="2024-05-29T00:42:03.918" v="49" actId="20577"/>
      <pc:docMkLst>
        <pc:docMk/>
      </pc:docMkLst>
      <pc:sldChg chg="modSp">
        <pc:chgData name="Laura Beaver" userId="" providerId="" clId="Web-{10823F44-C407-4217-A77D-36EA873C103F}" dt="2024-05-29T00:42:03.918" v="49" actId="20577"/>
        <pc:sldMkLst>
          <pc:docMk/>
          <pc:sldMk cId="4253947143" sldId="256"/>
        </pc:sldMkLst>
        <pc:spChg chg="mod">
          <ac:chgData name="Laura Beaver" userId="" providerId="" clId="Web-{10823F44-C407-4217-A77D-36EA873C103F}" dt="2024-05-29T00:42:03.918" v="49" actId="20577"/>
          <ac:spMkLst>
            <pc:docMk/>
            <pc:sldMk cId="4253947143" sldId="256"/>
            <ac:spMk id="4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B6A303-41D4-4FAC-1F7C-56C07BDD8C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28F3910-B2B6-AFE8-A1AD-BFF1F174B9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135CF6-590C-142C-B8DE-E84D3C7185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E892EE5-4944-9DB9-6AEF-733A921B76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011336-913E-743F-5CA3-18EFB4247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5962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608F2-4FEC-046F-9615-1B681256F6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059137-6E37-0165-0874-C4534788FB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33B766C-BB88-827F-0482-09EE9D23AE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95689A-6829-8AC8-89CC-588EFAEBD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0832EF-477C-6156-AD36-263563A5B1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78583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3DEB0F6-D997-5456-99FE-6DC36A1BB6D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BE3675-B155-10F0-0A5A-352F51520C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A2D7AD-ABC3-6683-DD69-024FE13D5F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2067B5-25E8-1E49-C73A-D66AA230D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0B09A5-1464-A5C4-B201-96E502F3D0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8577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72F31A-095F-B2ED-CAF1-530CD98C0B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A59E73-2306-B1A9-3FBD-A131649AFF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BE461E-F28A-158C-3794-48C14625C0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C1DBF8-6EBF-0CAE-B828-036B929CD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1A76FB-D5FC-33F4-57BA-FFF57C76E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820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2EE2A-85BC-93A3-FF68-56EB80976B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A85DF1C-F4EC-7D74-89FB-561904FF4EF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EC5145-70C4-A3A5-9477-F303B7BA43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8D371C-115C-6983-D058-CDD71B6EA3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6C13C7-F20E-418D-E296-2FABF8913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1137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3B778B-3D1D-C015-0EE4-085BFA7E1A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AD898A-AA38-0D83-A175-3DD15209DE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1DD34BE-652A-0849-DEB9-994074F981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4EBD6B-3D9A-3080-CF44-0EBEC766AB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BFC311-C577-FD71-E144-42783E6FF0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191E8E6-4A0C-7D64-CF3D-272F94A8D2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791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7909FC-C234-9955-C31D-DD33A1653C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A5AB31-1938-79E7-95D2-4D0FEB1555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106E28D-D1CF-3FBC-EFD6-F45E4C1256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0C838B0-5416-6B49-2C46-14102FA4315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D76C1BD-E057-A682-A7E7-B302292F0FF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3AD8358-0BBA-3C63-3E72-6540EB1286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B6A8CD-B890-94FE-C635-41E3B2962A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49473E1-2ECB-6EBF-CE43-77341A18E8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94123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D8DB69-65A5-ED45-A560-C7D0808D61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29E0988-B724-D023-895A-DBB67F4E5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80CCBC2-4C00-0E71-EE76-9D5A92327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2D4C80A-54D8-2DEF-3FD0-4BD452309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4277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A38F991-9E1F-CF61-D34C-74B0ED3D1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9CBA0D-8793-BA12-037C-E66833151E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2DF62BF-7FDC-8DAA-DA1F-7F64528AC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994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1BA5AC-06A6-A676-F5FF-96194FAA94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897652-6A5F-AB8F-217C-1E97434CF6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CB8544C-AED8-6FF6-1DBF-D4D16A38B8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7982569-0CA6-B2FD-BF8D-CF4809C910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2D3EA8B-4EA7-005A-9424-E8238CFEA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CE8658-32BD-87FC-8491-58EC909F7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45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94E250-BF8B-5B58-5F56-6183FC3E9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B8B4877-7939-F730-356A-BCBC863CA5A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F8BA57-C976-2845-093E-B015591031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96B1D1-8339-4079-D76F-297B505C5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E4AC7D-6A44-FB3D-F56E-2FFAF09D60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B65300-9F9F-71D9-C317-75E094902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57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938C89-9453-C63A-F888-3345D23773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7CF2DB-5AF2-0E68-E827-6EB9CB8BEA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2369EB-E9D7-41AD-AB73-84CDCCD0BD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73A21DA-4C2D-1044-9AE6-A0863C0421F5}" type="datetimeFigureOut">
              <a:rPr lang="en-US" smtClean="0"/>
              <a:t>5/2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4E4653-7454-FE7D-0752-08664DE0F7D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DB347F-861F-DC67-5C67-A1C0C254BA1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08EFCCB-440B-2E4A-B3D6-AEB3EC47C5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928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600082-4E45-11FE-F747-A5FE433D81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32560" y="2006283"/>
            <a:ext cx="9144000" cy="973137"/>
          </a:xfrm>
        </p:spPr>
        <p:txBody>
          <a:bodyPr>
            <a:normAutofit/>
          </a:bodyPr>
          <a:lstStyle/>
          <a:p>
            <a:r>
              <a:rPr lang="en-US" sz="44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</a:t>
            </a:r>
          </a:p>
        </p:txBody>
      </p:sp>
      <p:sp>
        <p:nvSpPr>
          <p:cNvPr id="4" name="Rectangle 3"/>
          <p:cNvSpPr/>
          <p:nvPr/>
        </p:nvSpPr>
        <p:spPr>
          <a:xfrm>
            <a:off x="3002420" y="3162846"/>
            <a:ext cx="6166747" cy="1754326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pPr algn="just"/>
            <a:r>
              <a:rPr lang="en-US" dirty="0">
                <a:latin typeface="Arial"/>
                <a:cs typeface="Arial"/>
              </a:rPr>
              <a:t>The following slides contain MS/MS data of features where label was detected. MS/MS spectra are from unlabeled samples and thus no deuterium is expected to effect the indicated values. The x-axis indicate the m/z of the fragment ions while the y-axis is intensity.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394714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0D5B98AA-0845-37A6-B8AA-B9B956D5F0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lards Urine - Positive</a:t>
            </a:r>
          </a:p>
        </p:txBody>
      </p:sp>
    </p:spTree>
    <p:extLst>
      <p:ext uri="{BB962C8B-B14F-4D97-AF65-F5344CB8AC3E}">
        <p14:creationId xmlns:p14="http://schemas.microsoft.com/office/powerpoint/2010/main" val="10134918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28CD36C0-438D-E178-F169-C052C511F2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8360" y="1219200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451929" y="5029200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727776" y="2876378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525770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0D5B98AA-0845-37A6-B8AA-B9B956D5F0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lards Urine - Negative</a:t>
            </a:r>
          </a:p>
        </p:txBody>
      </p:sp>
    </p:spTree>
    <p:extLst>
      <p:ext uri="{BB962C8B-B14F-4D97-AF65-F5344CB8AC3E}">
        <p14:creationId xmlns:p14="http://schemas.microsoft.com/office/powerpoint/2010/main" val="136644935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A7D33EF-9E87-AF9B-3A63-193DCD96B1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0" y="1524000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69644" y="5334000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896142" y="3202950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00746388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1BF42B7F-07A7-4A5F-CED1-37AB9845339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0" y="1524000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730421" y="5334000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896142" y="3290500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586725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3373796" y="1040892"/>
            <a:ext cx="5064760" cy="4051808"/>
            <a:chOff x="6939956" y="141732"/>
            <a:chExt cx="5064760" cy="405180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0525588-B172-26F9-13AC-BA529D57DBA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939956" y="141732"/>
              <a:ext cx="5064760" cy="4051808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9769516" y="38501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4.0602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020976" y="104033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09.0837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524380" y="1148060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1.0289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675484" y="2057842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3.029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859902" y="1881540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9.9569</a:t>
              </a: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5372100" y="5074718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2713938" y="2926224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4367790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3493176" y="1041342"/>
            <a:ext cx="5099644" cy="4079715"/>
            <a:chOff x="5992536" y="309822"/>
            <a:chExt cx="5099644" cy="407971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2632B06-5988-8892-97D5-0A37810B6D5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992536" y="309822"/>
              <a:ext cx="5099644" cy="407971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9137056" y="310535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5.055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8504258" y="3050976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0.0344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397916" y="3409324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4.036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123596" y="54503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3.045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001096" y="49169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1.0409</a:t>
              </a:r>
            </a:p>
          </p:txBody>
        </p:sp>
      </p:grpSp>
      <p:sp>
        <p:nvSpPr>
          <p:cNvPr id="12" name="TextBox 11"/>
          <p:cNvSpPr txBox="1"/>
          <p:nvPr/>
        </p:nvSpPr>
        <p:spPr>
          <a:xfrm>
            <a:off x="5705929" y="4967216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2833318" y="2942699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861204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543EF8-07B3-4E08-05B4-55528D4842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lards Plasma - Positive</a:t>
            </a:r>
          </a:p>
        </p:txBody>
      </p:sp>
    </p:spTree>
    <p:extLst>
      <p:ext uri="{BB962C8B-B14F-4D97-AF65-F5344CB8AC3E}">
        <p14:creationId xmlns:p14="http://schemas.microsoft.com/office/powerpoint/2010/main" val="237853526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86FAA6F-77A2-F1C2-3A2C-0AC1294A37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0" y="1524000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04329" y="5264758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896142" y="3231979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005034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57B7188-004D-C41D-5B0B-3AAA1FB3233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0" y="1524000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18844" y="5334000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896142" y="3202950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93048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35C314-5903-9569-7EC6-E20F34C3B6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occoli Urine - Negative</a:t>
            </a:r>
          </a:p>
        </p:txBody>
      </p:sp>
    </p:spTree>
    <p:extLst>
      <p:ext uri="{BB962C8B-B14F-4D97-AF65-F5344CB8AC3E}">
        <p14:creationId xmlns:p14="http://schemas.microsoft.com/office/powerpoint/2010/main" val="56459754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9EF36E20-A879-4462-E070-7D37E24208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0" y="1524000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633358" y="5334000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896142" y="3290500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2187724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70EAFF-3007-16D5-95FC-031C6F915E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llards Plasma - Negative</a:t>
            </a:r>
          </a:p>
        </p:txBody>
      </p:sp>
    </p:spTree>
    <p:extLst>
      <p:ext uri="{BB962C8B-B14F-4D97-AF65-F5344CB8AC3E}">
        <p14:creationId xmlns:p14="http://schemas.microsoft.com/office/powerpoint/2010/main" val="289176271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3592522" y="860525"/>
            <a:ext cx="5724826" cy="4037465"/>
            <a:chOff x="6310555" y="894081"/>
            <a:chExt cx="5724826" cy="4037465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A5F64BE-B118-EE0B-7FE8-0192E3E99928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310555" y="894081"/>
              <a:ext cx="5046831" cy="4037465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734586" y="3962401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4.9985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616128" y="1069405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0.0871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409430" y="3746957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0.0817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1087425" y="3746957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0.0925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748053" y="4177845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6.0315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8505287" y="4285567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2.0649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007534" y="4319123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71.0139</a:t>
              </a: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5612397" y="4836258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6200000">
            <a:off x="2932664" y="2651408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12220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716468" y="1155551"/>
            <a:ext cx="5080000" cy="3810000"/>
            <a:chOff x="5667188" y="2191871"/>
            <a:chExt cx="5080000" cy="3810000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11704DA8-F43A-1BDB-33C6-15A7361566C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67188" y="2191871"/>
              <a:ext cx="5080000" cy="3810000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6862693" y="3384697"/>
              <a:ext cx="6125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5.0391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862692" y="4169557"/>
              <a:ext cx="61252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3.0243</a:t>
              </a:r>
            </a:p>
          </p:txBody>
        </p:sp>
      </p:grpSp>
      <p:sp>
        <p:nvSpPr>
          <p:cNvPr id="2" name="TextBox 1"/>
          <p:cNvSpPr txBox="1"/>
          <p:nvPr/>
        </p:nvSpPr>
        <p:spPr>
          <a:xfrm>
            <a:off x="5705929" y="4967216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2995635" y="2731236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11802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3434080" y="1152626"/>
            <a:ext cx="5240020" cy="4015232"/>
            <a:chOff x="6664960" y="832586"/>
            <a:chExt cx="5240020" cy="4015232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46148D5-E0A8-0161-4DA3-B8DC64C01F9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664960" y="832586"/>
              <a:ext cx="5019040" cy="4015232"/>
            </a:xfrm>
            <a:prstGeom prst="rect">
              <a:avLst/>
            </a:prstGeom>
          </p:spPr>
        </p:pic>
        <p:sp>
          <p:nvSpPr>
            <p:cNvPr id="7" name="TextBox 6"/>
            <p:cNvSpPr txBox="1"/>
            <p:nvPr/>
          </p:nvSpPr>
          <p:spPr>
            <a:xfrm>
              <a:off x="10957024" y="3300391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10.1192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226524" y="1683353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93.0335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962364" y="115024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74.0159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720608" y="329803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56.0042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402840" y="3453833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3.0272</a:t>
              </a:r>
            </a:p>
          </p:txBody>
        </p:sp>
      </p:grpSp>
      <p:sp>
        <p:nvSpPr>
          <p:cNvPr id="13" name="TextBox 12"/>
          <p:cNvSpPr txBox="1"/>
          <p:nvPr/>
        </p:nvSpPr>
        <p:spPr>
          <a:xfrm>
            <a:off x="5578021" y="5167858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6200000">
            <a:off x="2691741" y="2890893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48563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CB8292B-1AF8-5A39-C8C3-227E0E671B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6000" y="1524000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582558" y="5334000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896142" y="3210207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98153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6D70D9-15BE-C417-0C89-4B9261F4DA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roccoli Urine - Positive</a:t>
            </a:r>
          </a:p>
        </p:txBody>
      </p:sp>
    </p:spTree>
    <p:extLst>
      <p:ext uri="{BB962C8B-B14F-4D97-AF65-F5344CB8AC3E}">
        <p14:creationId xmlns:p14="http://schemas.microsoft.com/office/powerpoint/2010/main" val="7218989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759200" y="860652"/>
            <a:ext cx="5311370" cy="4021328"/>
            <a:chOff x="6052820" y="1066392"/>
            <a:chExt cx="5311370" cy="402132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6C749F9F-3EA6-7DCD-A8AE-F9C921FFCC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52820" y="1066392"/>
              <a:ext cx="5026660" cy="4021328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6926274" y="133100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0.0759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8983674" y="4309386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69.1194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0416234" y="4133084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12.171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561746" y="2950002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30.0653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842148" y="3322355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5.0515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363626" y="3847713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17.058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348386" y="3399597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28.0513</a:t>
              </a: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5906951" y="4881980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6200000">
            <a:off x="3099342" y="2821206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6247503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7EFBD572-08FC-B9CB-056D-A26DEBA789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46275" y="1347831"/>
            <a:ext cx="5080000" cy="3810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357586" y="5157831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6200000">
            <a:off x="2686417" y="3050550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001460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98232" y="1217864"/>
            <a:ext cx="5023698" cy="3965010"/>
            <a:chOff x="5227972" y="684464"/>
            <a:chExt cx="5023698" cy="396501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BA46CF36-A03F-FF9D-908D-0398949680E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227972" y="684464"/>
              <a:ext cx="4956263" cy="396501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6062444" y="1485289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60.0787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536422" y="1024348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12.029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837024" y="1239792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27.0164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8145474" y="1347514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389.0603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9303714" y="3062014"/>
              <a:ext cx="9479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517.1254</a:t>
              </a:r>
            </a:p>
          </p:txBody>
        </p:sp>
      </p:grpSp>
      <p:sp>
        <p:nvSpPr>
          <p:cNvPr id="11" name="TextBox 10"/>
          <p:cNvSpPr txBox="1"/>
          <p:nvPr/>
        </p:nvSpPr>
        <p:spPr>
          <a:xfrm>
            <a:off x="5524501" y="5182874"/>
            <a:ext cx="7311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m/z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6200000">
            <a:off x="2838374" y="2796550"/>
            <a:ext cx="1042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ntensity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382462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3</TotalTime>
  <Words>140</Words>
  <Application>Microsoft Office PowerPoint</Application>
  <PresentationFormat>Widescreen</PresentationFormat>
  <Paragraphs>74</Paragraphs>
  <Slides>2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2</vt:i4>
      </vt:variant>
    </vt:vector>
  </HeadingPairs>
  <TitlesOfParts>
    <vt:vector size="26" baseType="lpstr">
      <vt:lpstr>Aptos</vt:lpstr>
      <vt:lpstr>Aptos Display</vt:lpstr>
      <vt:lpstr>Arial</vt:lpstr>
      <vt:lpstr>Office Theme</vt:lpstr>
      <vt:lpstr>Supplemental Figure S3</vt:lpstr>
      <vt:lpstr>Broccoli Urine - Negative</vt:lpstr>
      <vt:lpstr>PowerPoint Presentation</vt:lpstr>
      <vt:lpstr>PowerPoint Presentation</vt:lpstr>
      <vt:lpstr>PowerPoint Presentation</vt:lpstr>
      <vt:lpstr>Broccoli Urine - Positive</vt:lpstr>
      <vt:lpstr>PowerPoint Presentation</vt:lpstr>
      <vt:lpstr>PowerPoint Presentation</vt:lpstr>
      <vt:lpstr>PowerPoint Presentation</vt:lpstr>
      <vt:lpstr>Collards Urine - Positive</vt:lpstr>
      <vt:lpstr>PowerPoint Presentation</vt:lpstr>
      <vt:lpstr>Collards Urine - Negative</vt:lpstr>
      <vt:lpstr>PowerPoint Presentation</vt:lpstr>
      <vt:lpstr>PowerPoint Presentation</vt:lpstr>
      <vt:lpstr>PowerPoint Presentation</vt:lpstr>
      <vt:lpstr>PowerPoint Presentation</vt:lpstr>
      <vt:lpstr>Collards Plasma - Positive</vt:lpstr>
      <vt:lpstr>PowerPoint Presentation</vt:lpstr>
      <vt:lpstr>PowerPoint Presentation</vt:lpstr>
      <vt:lpstr>PowerPoint Presentation</vt:lpstr>
      <vt:lpstr>Collards Plasma - Negativ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MS2 Spectra for Label Paper</dc:title>
  <dc:creator>Bouranis, John Anthony</dc:creator>
  <cp:lastModifiedBy>Beaver, Laura Michelle</cp:lastModifiedBy>
  <cp:revision>57</cp:revision>
  <dcterms:created xsi:type="dcterms:W3CDTF">2024-05-18T18:43:56Z</dcterms:created>
  <dcterms:modified xsi:type="dcterms:W3CDTF">2024-05-29T21:55:25Z</dcterms:modified>
</cp:coreProperties>
</file>